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>
      <p:cViewPr varScale="1">
        <p:scale>
          <a:sx n="143" d="100"/>
          <a:sy n="143" d="100"/>
        </p:scale>
        <p:origin x="-1352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DE7FD-FD9B-4ABC-9327-0389DE42E10B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649C0-C799-4B75-9FA0-C8EDD889A9D8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DE7FD-FD9B-4ABC-9327-0389DE42E10B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649C0-C799-4B75-9FA0-C8EDD889A9D8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DE7FD-FD9B-4ABC-9327-0389DE42E10B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649C0-C799-4B75-9FA0-C8EDD889A9D8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DE7FD-FD9B-4ABC-9327-0389DE42E10B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649C0-C799-4B75-9FA0-C8EDD889A9D8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DE7FD-FD9B-4ABC-9327-0389DE42E10B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649C0-C799-4B75-9FA0-C8EDD889A9D8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DE7FD-FD9B-4ABC-9327-0389DE42E10B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649C0-C799-4B75-9FA0-C8EDD889A9D8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DE7FD-FD9B-4ABC-9327-0389DE42E10B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649C0-C799-4B75-9FA0-C8EDD889A9D8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DE7FD-FD9B-4ABC-9327-0389DE42E10B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649C0-C799-4B75-9FA0-C8EDD889A9D8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DE7FD-FD9B-4ABC-9327-0389DE42E10B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649C0-C799-4B75-9FA0-C8EDD889A9D8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DE7FD-FD9B-4ABC-9327-0389DE42E10B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649C0-C799-4B75-9FA0-C8EDD889A9D8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DE7FD-FD9B-4ABC-9327-0389DE42E10B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649C0-C799-4B75-9FA0-C8EDD889A9D8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CDE7FD-FD9B-4ABC-9327-0389DE42E10B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B649C0-C799-4B75-9FA0-C8EDD889A9D8}" type="slidenum">
              <a:rPr lang="fr-CA" smtClean="0"/>
              <a:pPr/>
              <a:t>‹#›</a:t>
            </a:fld>
            <a:endParaRPr lang="fr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39312600"/>
              </p:ext>
            </p:extLst>
          </p:nvPr>
        </p:nvGraphicFramePr>
        <p:xfrm>
          <a:off x="1000100" y="855317"/>
          <a:ext cx="7215238" cy="5380196"/>
        </p:xfrm>
        <a:graphic>
          <a:graphicData uri="http://schemas.openxmlformats.org/drawingml/2006/table">
            <a:tbl>
              <a:tblPr/>
              <a:tblGrid>
                <a:gridCol w="2197384"/>
                <a:gridCol w="741064"/>
                <a:gridCol w="1194552"/>
                <a:gridCol w="1530573"/>
                <a:gridCol w="1551665"/>
              </a:tblGrid>
              <a:tr h="196344">
                <a:tc>
                  <a:txBody>
                    <a:bodyPr/>
                    <a:lstStyle/>
                    <a:p>
                      <a:pPr algn="ctr" fontAlgn="b"/>
                      <a:endParaRPr lang="fr-CA" sz="1200" b="1" i="0" u="none" strike="noStrike" dirty="0" smtClean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  <a:p>
                      <a:pPr algn="ctr" fontAlgn="b"/>
                      <a:r>
                        <a:rPr lang="fr-CA" sz="1200" b="1" i="0" u="none" strike="noStrike" dirty="0" err="1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Antibody</a:t>
                      </a:r>
                      <a:endParaRPr lang="fr-CA" sz="1200" b="1" i="0" u="none" strike="noStrike" dirty="0" smtClean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  <a:p>
                      <a:pPr algn="ctr" fontAlgn="b"/>
                      <a:endParaRPr lang="fr-CA" sz="1200" b="1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1" i="0" u="none" strike="noStrike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Dilution</a:t>
                      </a:r>
                    </a:p>
                    <a:p>
                      <a:pPr algn="ctr" fontAlgn="b"/>
                      <a:endParaRPr lang="fr-CA" sz="1200" b="1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1" i="0" u="none" strike="noStrike" dirty="0" err="1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ompany</a:t>
                      </a:r>
                      <a:endParaRPr lang="fr-CA" sz="1200" b="1" i="0" u="none" strike="noStrike" dirty="0" smtClean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  <a:p>
                      <a:pPr algn="ctr" fontAlgn="b"/>
                      <a:endParaRPr lang="fr-CA" sz="1200" b="1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1" i="0" u="none" strike="noStrike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atalog</a:t>
                      </a:r>
                      <a:r>
                        <a:rPr lang="fr-CA" sz="1200" b="1" i="0" u="none" strike="noStrike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lang="fr-CA" sz="1200" b="1" i="0" u="none" strike="noStrike" dirty="0" err="1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number</a:t>
                      </a:r>
                      <a:endParaRPr lang="fr-CA" sz="1200" b="1" i="0" u="none" strike="noStrike" dirty="0" smtClean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  <a:p>
                      <a:pPr algn="ctr" fontAlgn="b"/>
                      <a:endParaRPr lang="fr-CA" sz="1200" b="1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1" i="0" u="none" strike="noStrike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Additional</a:t>
                      </a:r>
                      <a:r>
                        <a:rPr lang="fr-CA" sz="1200" b="1" i="0" u="none" strike="noStrike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lang="fr-CA" sz="1200" b="1" i="0" u="none" strike="noStrike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information</a:t>
                      </a:r>
                    </a:p>
                    <a:p>
                      <a:pPr algn="ctr" fontAlgn="b"/>
                      <a:endParaRPr lang="fr-CA" sz="1200" b="1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6994"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6994"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LKB1</a:t>
                      </a:r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:7,000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Santa Cruz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32245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86994"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6994"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 dirty="0" err="1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AMPK</a:t>
                      </a:r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:7,000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ell Signaling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2532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6994"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6994"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p-</a:t>
                      </a:r>
                      <a:r>
                        <a:rPr lang="fr-CA" sz="1200" b="0" i="0" u="none" strike="noStrike" dirty="0" err="1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AMPK</a:t>
                      </a:r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:5,000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ell Signaling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2535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pT172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6994"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6994"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p-ACC</a:t>
                      </a:r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:10,000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ell Signaling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3661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pS79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6994"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6994"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S6 </a:t>
                      </a:r>
                      <a:r>
                        <a:rPr lang="fr-CA" sz="1200" b="0" i="0" u="none" strike="noStrike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ibosomal </a:t>
                      </a:r>
                      <a:r>
                        <a:rPr lang="fr-CA" sz="1200" b="0" i="0" u="none" strike="noStrike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protein</a:t>
                      </a:r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:10,000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ell Signaling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2217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6994"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6994"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p-S6 </a:t>
                      </a:r>
                      <a:r>
                        <a:rPr lang="fr-CA" sz="1200" b="0" i="0" u="none" strike="noStrike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ibosomal </a:t>
                      </a:r>
                      <a:r>
                        <a:rPr lang="fr-CA" sz="1200" b="0" i="0" u="none" strike="noStrike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protein</a:t>
                      </a:r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:20,000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ell Signaling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2215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pS240/44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6994"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6994"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lang="fr-CA" sz="1200" b="0" i="0" u="none" strike="noStrike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4E-</a:t>
                      </a:r>
                      <a:r>
                        <a:rPr lang="fr-CA" sz="1200" b="0" i="0" u="none" strike="noStrike" dirty="0" err="1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BP1</a:t>
                      </a:r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:20,000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ell Signaling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9452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6994"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6994"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lang="fr-CA" sz="1200" b="0" i="0" u="none" strike="noStrike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p-4E-</a:t>
                      </a:r>
                      <a:r>
                        <a:rPr lang="fr-CA" sz="1200" b="0" i="0" u="none" strike="noStrike" dirty="0" err="1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BP1</a:t>
                      </a:r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:20,000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ell Signaling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9459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pT37/46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6994"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6994"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AKT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:1,000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ell Signaling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9272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6994"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6994"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p-</a:t>
                      </a:r>
                      <a:r>
                        <a:rPr lang="fr-CA" sz="1200" b="0" i="0" u="none" strike="noStrike" dirty="0" err="1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AKT</a:t>
                      </a:r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:1,000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ell Signaling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9271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pS473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6994"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6344">
                <a:tc>
                  <a:txBody>
                    <a:bodyPr/>
                    <a:lstStyle/>
                    <a:p>
                      <a:pPr algn="ctr" fontAlgn="b"/>
                      <a:r>
                        <a:rPr lang="el-GR" sz="1200" b="0" i="0" u="none" strike="noStrike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β-</a:t>
                      </a:r>
                      <a:r>
                        <a:rPr lang="fr-CA" sz="1200" b="0" i="0" u="none" strike="noStrike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actin</a:t>
                      </a:r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:20,000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Sigma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A5441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6344"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6344"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  <a:sym typeface="Symbol"/>
                        </a:rPr>
                        <a:t>-</a:t>
                      </a:r>
                      <a:r>
                        <a:rPr lang="fr-CA" sz="1200" b="0" i="0" u="none" strike="noStrike" dirty="0" err="1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  <a:sym typeface="Symbol"/>
                        </a:rPr>
                        <a:t>tubulin</a:t>
                      </a:r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:50,000</a:t>
                      </a:r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Sigma</a:t>
                      </a:r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1200" b="0" i="0" u="none" strike="noStrike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T9026</a:t>
                      </a:r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6344"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350" marR="9350" marT="9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928662" y="404664"/>
            <a:ext cx="4572000" cy="307777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Table S1. List of </a:t>
            </a:r>
            <a:r>
              <a:rPr lang="en-US" sz="1400" b="1" dirty="0" smtClean="0">
                <a:latin typeface="Arial"/>
                <a:cs typeface="Arial"/>
              </a:rPr>
              <a:t>antibodies</a:t>
            </a:r>
            <a:endParaRPr lang="fr-CA" sz="1400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7473152" y="6518248"/>
            <a:ext cx="16419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 err="1" smtClean="0">
                <a:latin typeface="Arial" pitchFamily="34" charset="0"/>
                <a:cs typeface="Arial" pitchFamily="34" charset="0"/>
              </a:rPr>
              <a:t>Dupuy</a:t>
            </a:r>
            <a:r>
              <a:rPr lang="en-CA" sz="1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CA" sz="1400" i="1" dirty="0" smtClean="0">
                <a:latin typeface="Arial" pitchFamily="34" charset="0"/>
                <a:cs typeface="Arial" pitchFamily="34" charset="0"/>
              </a:rPr>
              <a:t>et al</a:t>
            </a:r>
            <a:r>
              <a:rPr lang="en-CA" sz="1400" dirty="0" smtClean="0">
                <a:latin typeface="Arial" pitchFamily="34" charset="0"/>
                <a:cs typeface="Arial" pitchFamily="34" charset="0"/>
              </a:rPr>
              <a:t>., 2013</a:t>
            </a:r>
            <a:endParaRPr lang="en-CA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135</Words>
  <Application>Microsoft Macintosh PowerPoint</Application>
  <PresentationFormat>On-screen Show (4:3)</PresentationFormat>
  <Paragraphs>62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anny</dc:creator>
  <cp:lastModifiedBy>Russell Jones</cp:lastModifiedBy>
  <cp:revision>9</cp:revision>
  <dcterms:created xsi:type="dcterms:W3CDTF">2013-07-10T16:19:23Z</dcterms:created>
  <dcterms:modified xsi:type="dcterms:W3CDTF">2013-07-10T16:20:44Z</dcterms:modified>
</cp:coreProperties>
</file>